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FF5BBD-502F-477C-A7D0-319F1D3E61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A82F77A-BF71-4A04-9F6F-4C6E7C5F46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BBF56F-289F-4F45-A864-FF8168C28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641CD0-532F-427E-AEAB-00A939EEC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74A597-EBE6-4321-A196-B44305E28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441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C86ACC-5C9B-4124-90F7-BDA325D4D1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DB5D62A-5A30-43DD-883A-1ED0764521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1AC7B04-6D5E-4EC4-A657-99F51461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67D7E7-AF4B-44EF-8B1D-D11E8E9E8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066A9B-0D48-4B36-990F-2AE6F31AE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2884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195C8F4-4EAE-4175-A221-93D29ED947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76ABC0F-D9EB-4782-B3AA-3990DFCC7C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C66359-930D-456D-BBF8-36AA06577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EC5174-3C07-41BB-8188-58CA64222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7E34F2-70AC-47AD-A130-8D29073F8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5875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5931BC-C71C-41C2-BDBC-046ED607A6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A6AA958-6A2B-4E22-8DCC-772ADD0B4F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F738345-E815-4C23-8BFA-CE51867A0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D5D9FF6-715A-4EA5-B6E7-47E030A91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0E8C44E-A866-42F5-BBF9-833830BF7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4122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87D43A3-A600-4011-90D4-6001733E90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2721D04-5717-454E-8AD8-CE54FA81F2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5504B48-DDAA-4A08-B8B8-728A342CF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2E77A3B-59C5-4C4D-96B1-2A4244FD8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2F5A1F5-BADB-492D-AD72-0A3ED38D9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1728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EFE7B94-024D-464F-A099-1AD2EEFEB2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10F5D26-724C-41E5-B65C-5D9DCD34D9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3385C1D-8192-46B6-9BAF-7912D45B33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6E162D6-0197-4BA9-B687-EAD2D521E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658E034-B464-40FF-8D66-FDD6774AE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B3F32F0-7065-4A98-869D-11F391C5B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6844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8B9B9B-33D0-4B63-9BEF-177A0B346C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7846B69-222A-405E-A906-6E4F8F4BAE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94EF26C-3F20-4E47-B9D7-5AD1170AAD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3487155-AB46-4E2D-AA4B-36A3FF2175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860D607-87E3-475F-B4FD-06A4D8961B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D949E17-732E-4BB9-9A06-CD557B4CF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9335198-B794-4B34-94AC-9BDA77E6C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2AD9A80-F3FB-4325-BC01-8AD45A278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3036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A615E1-935A-4267-B4C8-A59D89558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6C26880-F9A8-4EB3-9FA4-7D1A5D228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1CB6C15-C3D1-4073-A594-89B9D317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0503C42-AFA2-4093-95B0-57487434E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3732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7CFD290-FAD8-4E0C-847A-303A55782A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54540F0-235F-4A75-8635-B2D064A67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33B88A9-CBAC-47D3-BE64-6A60F1C5B2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2086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0A0E7BC-D63F-4BB3-AB1C-3849E76EE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34A56B4-8F27-46D9-B4CF-0C3FCA0ADB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0982413-17CD-4BB1-BE74-DF9B5D9D60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DF2A5B1-8DAF-4AA1-B50B-D44D15509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8173518-1256-46CB-B912-36974ADF3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9501787-438B-4C8B-BE8D-97E8B2DF1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494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641001-A9EA-495B-9FA4-D7F2B16AB3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67770AD-8029-4B43-BC76-AFC08A2385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CF0DDCD-C347-4A74-9F21-3CF99B63A0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7146AED-0B16-4B67-A938-E7320B5D8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AFA0723-3E6C-479F-996A-70B7EC5FE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728CFCC-FF39-4F4D-B219-6939CE467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4996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6F41C83-BB58-492D-9206-2AD59F8E9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41DFB8B-3EA9-4A68-90D2-904BC787C3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D82AE55-6E51-40E6-8A2A-B1458CF7EE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E51BF-08AC-4C7A-8C4E-0252BD1F16A9}" type="datetimeFigureOut">
              <a:rPr lang="fr-FR" smtClean="0"/>
              <a:t>19/08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F0C1264-2D64-40D3-943B-795C4E2A76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A62B65D-37A6-4354-A869-A72B6D5506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3806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4">
            <a:extLst>
              <a:ext uri="{FF2B5EF4-FFF2-40B4-BE49-F238E27FC236}">
                <a16:creationId xmlns:a16="http://schemas.microsoft.com/office/drawing/2014/main" id="{A726B157-5955-4A0B-BE18-A1E5C7F4CF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2788586"/>
              </p:ext>
            </p:extLst>
          </p:nvPr>
        </p:nvGraphicFramePr>
        <p:xfrm>
          <a:off x="3739350" y="1297173"/>
          <a:ext cx="4525692" cy="1680257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130362">
                  <a:extLst>
                    <a:ext uri="{9D8B030D-6E8A-4147-A177-3AD203B41FA5}">
                      <a16:colId xmlns:a16="http://schemas.microsoft.com/office/drawing/2014/main" val="3143408827"/>
                    </a:ext>
                  </a:extLst>
                </a:gridCol>
                <a:gridCol w="1258457">
                  <a:extLst>
                    <a:ext uri="{9D8B030D-6E8A-4147-A177-3AD203B41FA5}">
                      <a16:colId xmlns:a16="http://schemas.microsoft.com/office/drawing/2014/main" val="2658104883"/>
                    </a:ext>
                  </a:extLst>
                </a:gridCol>
                <a:gridCol w="1194119">
                  <a:extLst>
                    <a:ext uri="{9D8B030D-6E8A-4147-A177-3AD203B41FA5}">
                      <a16:colId xmlns:a16="http://schemas.microsoft.com/office/drawing/2014/main" val="824510381"/>
                    </a:ext>
                  </a:extLst>
                </a:gridCol>
                <a:gridCol w="942754">
                  <a:extLst>
                    <a:ext uri="{9D8B030D-6E8A-4147-A177-3AD203B41FA5}">
                      <a16:colId xmlns:a16="http://schemas.microsoft.com/office/drawing/2014/main" val="2266526667"/>
                    </a:ext>
                  </a:extLst>
                </a:gridCol>
              </a:tblGrid>
              <a:tr h="463762">
                <a:tc>
                  <a:txBody>
                    <a:bodyPr/>
                    <a:lstStyle/>
                    <a:p>
                      <a:pPr algn="ctr"/>
                      <a:r>
                        <a:rPr lang="fr-FR" sz="8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gen</a:t>
                      </a:r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I (</a:t>
                      </a:r>
                      <a:r>
                        <a:rPr lang="fr-F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spitalized</a:t>
                      </a:r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I (</a:t>
                      </a:r>
                      <a:r>
                        <a:rPr lang="fr-F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nhospitalized</a:t>
                      </a:r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94832116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5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8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61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0093113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.4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569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7198398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2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4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.2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1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1372540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D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8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.1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5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8755889"/>
                  </a:ext>
                </a:extLst>
              </a:tr>
              <a:tr h="24329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TD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8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901</a:t>
                      </a: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902102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8488F481-D82C-4B50-96A6-97C263FB42D3}"/>
              </a:ext>
            </a:extLst>
          </p:cNvPr>
          <p:cNvSpPr txBox="1"/>
          <p:nvPr/>
        </p:nvSpPr>
        <p:spPr>
          <a:xfrm>
            <a:off x="3628294" y="837169"/>
            <a:ext cx="52556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1.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SI) of the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body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ponse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gens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spitalized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on-</a:t>
            </a:r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spitalized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s. </a:t>
            </a:r>
          </a:p>
        </p:txBody>
      </p:sp>
    </p:spTree>
    <p:extLst>
      <p:ext uri="{BB962C8B-B14F-4D97-AF65-F5344CB8AC3E}">
        <p14:creationId xmlns:p14="http://schemas.microsoft.com/office/powerpoint/2010/main" val="8331516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Grand écran</PresentationFormat>
  <Paragraphs>2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émi Malbec</dc:creator>
  <cp:lastModifiedBy>Rémi Malbec</cp:lastModifiedBy>
  <cp:revision>16</cp:revision>
  <dcterms:created xsi:type="dcterms:W3CDTF">2021-06-23T09:50:32Z</dcterms:created>
  <dcterms:modified xsi:type="dcterms:W3CDTF">2021-08-19T09:58:46Z</dcterms:modified>
</cp:coreProperties>
</file>